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12"/>
  </p:notesMasterIdLst>
  <p:sldIdLst>
    <p:sldId id="256" r:id="rId5"/>
    <p:sldId id="328" r:id="rId6"/>
    <p:sldId id="330" r:id="rId7"/>
    <p:sldId id="277" r:id="rId8"/>
    <p:sldId id="347" r:id="rId9"/>
    <p:sldId id="344" r:id="rId10"/>
    <p:sldId id="279" r:id="rId11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9491E88-5726-B3E1-A0D2-0B1668AD2660}" name="Mark Harris" initials="" userId="S::micmh@leeds.ac.uk::bfd9a973-ac62-4e0f-994c-8e95fda04071" providerId="AD"/>
  <p188:author id="{40E98AEF-9237-B8D6-0EE8-7DEAE6D3E295}" name="Jinchao Guo" initials="" userId="S::jg0428@princeton.edu::ea6788d9-a8b8-40da-b4e2-f6aa1dc39f2b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000FF"/>
    <a:srgbClr val="6D870F"/>
    <a:srgbClr val="171E7F"/>
    <a:srgbClr val="08A876"/>
    <a:srgbClr val="45911F"/>
    <a:srgbClr val="768030"/>
    <a:srgbClr val="64753B"/>
    <a:srgbClr val="046CAC"/>
    <a:srgbClr val="007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1324" autoAdjust="0"/>
    <p:restoredTop sz="94660"/>
  </p:normalViewPr>
  <p:slideViewPr>
    <p:cSldViewPr snapToGrid="0">
      <p:cViewPr varScale="1">
        <p:scale>
          <a:sx n="75" d="100"/>
          <a:sy n="75" d="100"/>
        </p:scale>
        <p:origin x="3342" y="84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22" d="100"/>
        <a:sy n="12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18" Type="http://schemas.microsoft.com/office/2018/10/relationships/authors" Target="author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notesMaster" Target="notesMasters/notesMaster1.xml"/><Relationship Id="rId17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k Harris" userId="bfd9a973-ac62-4e0f-994c-8e95fda04071" providerId="ADAL" clId="{3BC29CC5-5EA0-4DD6-A305-9EA7379A06CF}"/>
    <pc:docChg chg="delSld">
      <pc:chgData name="Mark Harris" userId="bfd9a973-ac62-4e0f-994c-8e95fda04071" providerId="ADAL" clId="{3BC29CC5-5EA0-4DD6-A305-9EA7379A06CF}" dt="2025-03-12T14:35:00.650" v="0" actId="47"/>
      <pc:docMkLst>
        <pc:docMk/>
      </pc:docMkLst>
      <pc:sldChg chg="del">
        <pc:chgData name="Mark Harris" userId="bfd9a973-ac62-4e0f-994c-8e95fda04071" providerId="ADAL" clId="{3BC29CC5-5EA0-4DD6-A305-9EA7379A06CF}" dt="2025-03-12T14:35:00.650" v="0" actId="47"/>
        <pc:sldMkLst>
          <pc:docMk/>
          <pc:sldMk cId="3368565437" sldId="325"/>
        </pc:sldMkLst>
      </pc:sldChg>
      <pc:sldChg chg="del">
        <pc:chgData name="Mark Harris" userId="bfd9a973-ac62-4e0f-994c-8e95fda04071" providerId="ADAL" clId="{3BC29CC5-5EA0-4DD6-A305-9EA7379A06CF}" dt="2025-03-12T14:35:00.650" v="0" actId="47"/>
        <pc:sldMkLst>
          <pc:docMk/>
          <pc:sldMk cId="2983326443" sldId="329"/>
        </pc:sldMkLst>
      </pc:sldChg>
      <pc:sldChg chg="del">
        <pc:chgData name="Mark Harris" userId="bfd9a973-ac62-4e0f-994c-8e95fda04071" providerId="ADAL" clId="{3BC29CC5-5EA0-4DD6-A305-9EA7379A06CF}" dt="2025-03-12T14:35:00.650" v="0" actId="47"/>
        <pc:sldMkLst>
          <pc:docMk/>
          <pc:sldMk cId="4225022581" sldId="331"/>
        </pc:sldMkLst>
      </pc:sldChg>
      <pc:sldChg chg="del">
        <pc:chgData name="Mark Harris" userId="bfd9a973-ac62-4e0f-994c-8e95fda04071" providerId="ADAL" clId="{3BC29CC5-5EA0-4DD6-A305-9EA7379A06CF}" dt="2025-03-12T14:35:00.650" v="0" actId="47"/>
        <pc:sldMkLst>
          <pc:docMk/>
          <pc:sldMk cId="3027957484" sldId="332"/>
        </pc:sldMkLst>
      </pc:sldChg>
      <pc:sldChg chg="del">
        <pc:chgData name="Mark Harris" userId="bfd9a973-ac62-4e0f-994c-8e95fda04071" providerId="ADAL" clId="{3BC29CC5-5EA0-4DD6-A305-9EA7379A06CF}" dt="2025-03-12T14:35:00.650" v="0" actId="47"/>
        <pc:sldMkLst>
          <pc:docMk/>
          <pc:sldMk cId="519750003" sldId="335"/>
        </pc:sldMkLst>
      </pc:sldChg>
      <pc:sldChg chg="del">
        <pc:chgData name="Mark Harris" userId="bfd9a973-ac62-4e0f-994c-8e95fda04071" providerId="ADAL" clId="{3BC29CC5-5EA0-4DD6-A305-9EA7379A06CF}" dt="2025-03-12T14:35:00.650" v="0" actId="47"/>
        <pc:sldMkLst>
          <pc:docMk/>
          <pc:sldMk cId="701909753" sldId="340"/>
        </pc:sldMkLst>
      </pc:sldChg>
      <pc:sldChg chg="del">
        <pc:chgData name="Mark Harris" userId="bfd9a973-ac62-4e0f-994c-8e95fda04071" providerId="ADAL" clId="{3BC29CC5-5EA0-4DD6-A305-9EA7379A06CF}" dt="2025-03-12T14:35:00.650" v="0" actId="47"/>
        <pc:sldMkLst>
          <pc:docMk/>
          <pc:sldMk cId="4518876" sldId="350"/>
        </pc:sldMkLst>
      </pc:sldChg>
      <pc:sldChg chg="del">
        <pc:chgData name="Mark Harris" userId="bfd9a973-ac62-4e0f-994c-8e95fda04071" providerId="ADAL" clId="{3BC29CC5-5EA0-4DD6-A305-9EA7379A06CF}" dt="2025-03-12T14:35:00.650" v="0" actId="47"/>
        <pc:sldMkLst>
          <pc:docMk/>
          <pc:sldMk cId="311077379" sldId="354"/>
        </pc:sldMkLst>
      </pc:sldChg>
      <pc:sldChg chg="del">
        <pc:chgData name="Mark Harris" userId="bfd9a973-ac62-4e0f-994c-8e95fda04071" providerId="ADAL" clId="{3BC29CC5-5EA0-4DD6-A305-9EA7379A06CF}" dt="2025-03-12T14:35:00.650" v="0" actId="47"/>
        <pc:sldMkLst>
          <pc:docMk/>
          <pc:sldMk cId="4197390046" sldId="355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867CD7-98EF-441A-8F1E-CBD6312359C2}" type="datetimeFigureOut">
              <a:rPr lang="en-US" smtClean="0"/>
              <a:t>3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39838"/>
            <a:ext cx="2317750" cy="33512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5"/>
            <a:ext cx="5438140" cy="39086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28585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4" y="9428585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A31093-013C-4B28-B02E-555399C7BD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2972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46375" rtl="0" eaLnBrk="1" latinLnBrk="0" hangingPunct="1">
      <a:defRPr sz="455" kern="1200">
        <a:solidFill>
          <a:schemeClr val="tx1"/>
        </a:solidFill>
        <a:latin typeface="+mn-lt"/>
        <a:ea typeface="+mn-ea"/>
        <a:cs typeface="+mn-cs"/>
      </a:defRPr>
    </a:lvl1pPr>
    <a:lvl2pPr marL="173187" algn="l" defTabSz="346375" rtl="0" eaLnBrk="1" latinLnBrk="0" hangingPunct="1">
      <a:defRPr sz="455" kern="1200">
        <a:solidFill>
          <a:schemeClr val="tx1"/>
        </a:solidFill>
        <a:latin typeface="+mn-lt"/>
        <a:ea typeface="+mn-ea"/>
        <a:cs typeface="+mn-cs"/>
      </a:defRPr>
    </a:lvl2pPr>
    <a:lvl3pPr marL="346375" algn="l" defTabSz="346375" rtl="0" eaLnBrk="1" latinLnBrk="0" hangingPunct="1">
      <a:defRPr sz="455" kern="1200">
        <a:solidFill>
          <a:schemeClr val="tx1"/>
        </a:solidFill>
        <a:latin typeface="+mn-lt"/>
        <a:ea typeface="+mn-ea"/>
        <a:cs typeface="+mn-cs"/>
      </a:defRPr>
    </a:lvl3pPr>
    <a:lvl4pPr marL="519562" algn="l" defTabSz="346375" rtl="0" eaLnBrk="1" latinLnBrk="0" hangingPunct="1">
      <a:defRPr sz="455" kern="1200">
        <a:solidFill>
          <a:schemeClr val="tx1"/>
        </a:solidFill>
        <a:latin typeface="+mn-lt"/>
        <a:ea typeface="+mn-ea"/>
        <a:cs typeface="+mn-cs"/>
      </a:defRPr>
    </a:lvl4pPr>
    <a:lvl5pPr marL="692749" algn="l" defTabSz="346375" rtl="0" eaLnBrk="1" latinLnBrk="0" hangingPunct="1">
      <a:defRPr sz="455" kern="1200">
        <a:solidFill>
          <a:schemeClr val="tx1"/>
        </a:solidFill>
        <a:latin typeface="+mn-lt"/>
        <a:ea typeface="+mn-ea"/>
        <a:cs typeface="+mn-cs"/>
      </a:defRPr>
    </a:lvl5pPr>
    <a:lvl6pPr marL="865937" algn="l" defTabSz="346375" rtl="0" eaLnBrk="1" latinLnBrk="0" hangingPunct="1">
      <a:defRPr sz="455" kern="1200">
        <a:solidFill>
          <a:schemeClr val="tx1"/>
        </a:solidFill>
        <a:latin typeface="+mn-lt"/>
        <a:ea typeface="+mn-ea"/>
        <a:cs typeface="+mn-cs"/>
      </a:defRPr>
    </a:lvl6pPr>
    <a:lvl7pPr marL="1039124" algn="l" defTabSz="346375" rtl="0" eaLnBrk="1" latinLnBrk="0" hangingPunct="1">
      <a:defRPr sz="455" kern="1200">
        <a:solidFill>
          <a:schemeClr val="tx1"/>
        </a:solidFill>
        <a:latin typeface="+mn-lt"/>
        <a:ea typeface="+mn-ea"/>
        <a:cs typeface="+mn-cs"/>
      </a:defRPr>
    </a:lvl7pPr>
    <a:lvl8pPr marL="1212312" algn="l" defTabSz="346375" rtl="0" eaLnBrk="1" latinLnBrk="0" hangingPunct="1">
      <a:defRPr sz="455" kern="1200">
        <a:solidFill>
          <a:schemeClr val="tx1"/>
        </a:solidFill>
        <a:latin typeface="+mn-lt"/>
        <a:ea typeface="+mn-ea"/>
        <a:cs typeface="+mn-cs"/>
      </a:defRPr>
    </a:lvl8pPr>
    <a:lvl9pPr marL="1385499" algn="l" defTabSz="346375" rtl="0" eaLnBrk="1" latinLnBrk="0" hangingPunct="1">
      <a:defRPr sz="45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9963" y="1239838"/>
            <a:ext cx="2317750" cy="3351212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A31093-013C-4B28-B02E-555399C7BDCE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1900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A68C-D90C-4ACC-92E1-4A7E12A30630}" type="datetimeFigureOut">
              <a:rPr lang="en-US" smtClean="0"/>
              <a:t>3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279-7955-46EF-B161-33EB382E9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8363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A68C-D90C-4ACC-92E1-4A7E12A30630}" type="datetimeFigureOut">
              <a:rPr lang="en-US" smtClean="0"/>
              <a:t>3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279-7955-46EF-B161-33EB382E9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233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A68C-D90C-4ACC-92E1-4A7E12A30630}" type="datetimeFigureOut">
              <a:rPr lang="en-US" smtClean="0"/>
              <a:t>3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279-7955-46EF-B161-33EB382E9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875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A68C-D90C-4ACC-92E1-4A7E12A30630}" type="datetimeFigureOut">
              <a:rPr lang="en-US" smtClean="0"/>
              <a:t>3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279-7955-46EF-B161-33EB382E9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904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A68C-D90C-4ACC-92E1-4A7E12A30630}" type="datetimeFigureOut">
              <a:rPr lang="en-US" smtClean="0"/>
              <a:t>3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279-7955-46EF-B161-33EB382E9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1795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A68C-D90C-4ACC-92E1-4A7E12A30630}" type="datetimeFigureOut">
              <a:rPr lang="en-US" smtClean="0"/>
              <a:t>3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279-7955-46EF-B161-33EB382E9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182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A68C-D90C-4ACC-92E1-4A7E12A30630}" type="datetimeFigureOut">
              <a:rPr lang="en-US" smtClean="0"/>
              <a:t>3/1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279-7955-46EF-B161-33EB382E9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037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A68C-D90C-4ACC-92E1-4A7E12A30630}" type="datetimeFigureOut">
              <a:rPr lang="en-US" smtClean="0"/>
              <a:t>3/1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279-7955-46EF-B161-33EB382E9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222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A68C-D90C-4ACC-92E1-4A7E12A30630}" type="datetimeFigureOut">
              <a:rPr lang="en-US" smtClean="0"/>
              <a:t>3/1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279-7955-46EF-B161-33EB382E9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00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A68C-D90C-4ACC-92E1-4A7E12A30630}" type="datetimeFigureOut">
              <a:rPr lang="en-US" smtClean="0"/>
              <a:t>3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279-7955-46EF-B161-33EB382E9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0353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6A68C-D90C-4ACC-92E1-4A7E12A30630}" type="datetimeFigureOut">
              <a:rPr lang="en-US" smtClean="0"/>
              <a:t>3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279-7955-46EF-B161-33EB382E9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609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F6A68C-D90C-4ACC-92E1-4A7E12A30630}" type="datetimeFigureOut">
              <a:rPr lang="en-US" smtClean="0"/>
              <a:t>3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D7F279-7955-46EF-B161-33EB382E9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030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tiff"/><Relationship Id="rId13" Type="http://schemas.openxmlformats.org/officeDocument/2006/relationships/image" Target="../media/image13.tiff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12.tiff"/><Relationship Id="rId17" Type="http://schemas.openxmlformats.org/officeDocument/2006/relationships/image" Target="../media/image15.emf"/><Relationship Id="rId2" Type="http://schemas.openxmlformats.org/officeDocument/2006/relationships/image" Target="../media/image6.png"/><Relationship Id="rId16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11.tiff"/><Relationship Id="rId5" Type="http://schemas.microsoft.com/office/2007/relationships/hdphoto" Target="../media/hdphoto2.wdp"/><Relationship Id="rId15" Type="http://schemas.openxmlformats.org/officeDocument/2006/relationships/image" Target="../media/image14.emf"/><Relationship Id="rId10" Type="http://schemas.microsoft.com/office/2007/relationships/hdphoto" Target="../media/hdphoto4.wdp"/><Relationship Id="rId4" Type="http://schemas.openxmlformats.org/officeDocument/2006/relationships/image" Target="../media/image7.png"/><Relationship Id="rId9" Type="http://schemas.openxmlformats.org/officeDocument/2006/relationships/image" Target="../media/image10.png"/><Relationship Id="rId14" Type="http://schemas.openxmlformats.org/officeDocument/2006/relationships/oleObject" Target="../embeddings/oleObject1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emf"/><Relationship Id="rId4" Type="http://schemas.openxmlformats.org/officeDocument/2006/relationships/image" Target="../media/image17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.bin"/><Relationship Id="rId13" Type="http://schemas.openxmlformats.org/officeDocument/2006/relationships/image" Target="../media/image24.emf"/><Relationship Id="rId3" Type="http://schemas.openxmlformats.org/officeDocument/2006/relationships/image" Target="../media/image19.emf"/><Relationship Id="rId7" Type="http://schemas.openxmlformats.org/officeDocument/2006/relationships/image" Target="../media/image21.emf"/><Relationship Id="rId12" Type="http://schemas.openxmlformats.org/officeDocument/2006/relationships/oleObject" Target="../embeddings/oleObject9.bin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6.bin"/><Relationship Id="rId11" Type="http://schemas.openxmlformats.org/officeDocument/2006/relationships/image" Target="../media/image23.emf"/><Relationship Id="rId5" Type="http://schemas.openxmlformats.org/officeDocument/2006/relationships/image" Target="../media/image20.emf"/><Relationship Id="rId10" Type="http://schemas.openxmlformats.org/officeDocument/2006/relationships/oleObject" Target="../embeddings/oleObject8.bin"/><Relationship Id="rId4" Type="http://schemas.openxmlformats.org/officeDocument/2006/relationships/oleObject" Target="../embeddings/oleObject5.bin"/><Relationship Id="rId9" Type="http://schemas.openxmlformats.org/officeDocument/2006/relationships/image" Target="../media/image22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tiff"/><Relationship Id="rId13" Type="http://schemas.openxmlformats.org/officeDocument/2006/relationships/image" Target="../media/image34.tiff"/><Relationship Id="rId18" Type="http://schemas.openxmlformats.org/officeDocument/2006/relationships/image" Target="../media/image38.tiff"/><Relationship Id="rId26" Type="http://schemas.openxmlformats.org/officeDocument/2006/relationships/image" Target="../media/image44.emf"/><Relationship Id="rId3" Type="http://schemas.openxmlformats.org/officeDocument/2006/relationships/image" Target="../media/image25.png"/><Relationship Id="rId21" Type="http://schemas.openxmlformats.org/officeDocument/2006/relationships/image" Target="../media/image41.tiff"/><Relationship Id="rId7" Type="http://schemas.openxmlformats.org/officeDocument/2006/relationships/image" Target="../media/image28.tiff"/><Relationship Id="rId12" Type="http://schemas.openxmlformats.org/officeDocument/2006/relationships/image" Target="../media/image33.tiff"/><Relationship Id="rId17" Type="http://schemas.openxmlformats.org/officeDocument/2006/relationships/image" Target="../media/image37.tiff"/><Relationship Id="rId25" Type="http://schemas.openxmlformats.org/officeDocument/2006/relationships/oleObject" Target="../embeddings/oleObject11.bin"/><Relationship Id="rId2" Type="http://schemas.openxmlformats.org/officeDocument/2006/relationships/notesSlide" Target="../notesSlides/notesSlide1.xml"/><Relationship Id="rId16" Type="http://schemas.microsoft.com/office/2007/relationships/hdphoto" Target="../media/hdphoto6.wdp"/><Relationship Id="rId20" Type="http://schemas.openxmlformats.org/officeDocument/2006/relationships/image" Target="../media/image4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tiff"/><Relationship Id="rId11" Type="http://schemas.openxmlformats.org/officeDocument/2006/relationships/image" Target="../media/image32.tiff"/><Relationship Id="rId24" Type="http://schemas.openxmlformats.org/officeDocument/2006/relationships/image" Target="../media/image43.emf"/><Relationship Id="rId5" Type="http://schemas.openxmlformats.org/officeDocument/2006/relationships/image" Target="../media/image26.tiff"/><Relationship Id="rId15" Type="http://schemas.openxmlformats.org/officeDocument/2006/relationships/image" Target="../media/image36.png"/><Relationship Id="rId23" Type="http://schemas.openxmlformats.org/officeDocument/2006/relationships/oleObject" Target="../embeddings/oleObject10.bin"/><Relationship Id="rId10" Type="http://schemas.openxmlformats.org/officeDocument/2006/relationships/image" Target="../media/image31.tiff"/><Relationship Id="rId19" Type="http://schemas.openxmlformats.org/officeDocument/2006/relationships/image" Target="../media/image39.tiff"/><Relationship Id="rId4" Type="http://schemas.microsoft.com/office/2007/relationships/hdphoto" Target="../media/hdphoto5.wdp"/><Relationship Id="rId9" Type="http://schemas.openxmlformats.org/officeDocument/2006/relationships/image" Target="../media/image30.tiff"/><Relationship Id="rId14" Type="http://schemas.openxmlformats.org/officeDocument/2006/relationships/image" Target="../media/image35.tiff"/><Relationship Id="rId22" Type="http://schemas.openxmlformats.org/officeDocument/2006/relationships/image" Target="../media/image4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TextBox 86">
            <a:extLst>
              <a:ext uri="{FF2B5EF4-FFF2-40B4-BE49-F238E27FC236}">
                <a16:creationId xmlns:a16="http://schemas.microsoft.com/office/drawing/2014/main" id="{F54A1EE2-108A-4D6F-9AD6-0EF4DE2B5DD2}"/>
              </a:ext>
            </a:extLst>
          </p:cNvPr>
          <p:cNvSpPr txBox="1"/>
          <p:nvPr/>
        </p:nvSpPr>
        <p:spPr>
          <a:xfrm>
            <a:off x="1040500" y="370249"/>
            <a:ext cx="363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9066D41E-61EF-471C-8322-8F869ADC0198}"/>
              </a:ext>
            </a:extLst>
          </p:cNvPr>
          <p:cNvSpPr txBox="1"/>
          <p:nvPr/>
        </p:nvSpPr>
        <p:spPr>
          <a:xfrm>
            <a:off x="1095153" y="1938511"/>
            <a:ext cx="2759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9140B6E-0278-8A16-D13D-CBF13C627B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5547" y="305394"/>
            <a:ext cx="3346905" cy="1613020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D81BAB70-264E-396E-C478-8DAA2C645E1F}"/>
              </a:ext>
            </a:extLst>
          </p:cNvPr>
          <p:cNvGrpSpPr/>
          <p:nvPr/>
        </p:nvGrpSpPr>
        <p:grpSpPr>
          <a:xfrm>
            <a:off x="1622721" y="5242067"/>
            <a:ext cx="3580866" cy="2588183"/>
            <a:chOff x="1300516" y="955668"/>
            <a:chExt cx="6120787" cy="494666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F85927DB-619B-853E-2E78-BE581123B3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15" t="6636" r="29087" b="12591"/>
            <a:stretch/>
          </p:blipFill>
          <p:spPr>
            <a:xfrm>
              <a:off x="1300516" y="955668"/>
              <a:ext cx="6120787" cy="4946666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2AD044B-62C5-7B68-38F2-D01EB7B71B7F}"/>
                </a:ext>
              </a:extLst>
            </p:cNvPr>
            <p:cNvSpPr txBox="1"/>
            <p:nvPr/>
          </p:nvSpPr>
          <p:spPr>
            <a:xfrm>
              <a:off x="1946328" y="2777922"/>
              <a:ext cx="940666" cy="485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219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91928EF-2231-00DD-A32A-EFE6A254207E}"/>
                </a:ext>
              </a:extLst>
            </p:cNvPr>
            <p:cNvSpPr txBox="1"/>
            <p:nvPr/>
          </p:nvSpPr>
          <p:spPr>
            <a:xfrm>
              <a:off x="1447708" y="4340127"/>
              <a:ext cx="997239" cy="485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0000D7"/>
                  </a:solidFill>
                  <a:highlight>
                    <a:srgbClr val="FFFFFF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W220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AFDE7F9-75ED-51B4-6007-6A10893F27BD}"/>
                </a:ext>
              </a:extLst>
            </p:cNvPr>
            <p:cNvSpPr txBox="1"/>
            <p:nvPr/>
          </p:nvSpPr>
          <p:spPr>
            <a:xfrm>
              <a:off x="2843322" y="2675270"/>
              <a:ext cx="940666" cy="485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18F71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218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3B154CD-99A1-5BF6-1556-AEC4D5D95DF6}"/>
                </a:ext>
              </a:extLst>
            </p:cNvPr>
            <p:cNvSpPr txBox="1"/>
            <p:nvPr/>
          </p:nvSpPr>
          <p:spPr>
            <a:xfrm>
              <a:off x="2886992" y="3563508"/>
              <a:ext cx="861462" cy="485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FE8A0A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22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6BDA78C-C837-7768-ADAC-ADEC1E9E13FF}"/>
                </a:ext>
              </a:extLst>
            </p:cNvPr>
            <p:cNvSpPr txBox="1"/>
            <p:nvPr/>
          </p:nvSpPr>
          <p:spPr>
            <a:xfrm>
              <a:off x="1327209" y="3563510"/>
              <a:ext cx="997237" cy="485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43F8F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246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75E92CE-DC04-B31E-C5DC-1F0402659C81}"/>
                </a:ext>
              </a:extLst>
            </p:cNvPr>
            <p:cNvSpPr txBox="1"/>
            <p:nvPr/>
          </p:nvSpPr>
          <p:spPr>
            <a:xfrm>
              <a:off x="1419425" y="2026380"/>
              <a:ext cx="997235" cy="485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B4F4B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249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D765C6A-F27D-F730-0BFB-308A9722B80D}"/>
                </a:ext>
              </a:extLst>
            </p:cNvPr>
            <p:cNvSpPr txBox="1"/>
            <p:nvPr/>
          </p:nvSpPr>
          <p:spPr>
            <a:xfrm>
              <a:off x="2344707" y="2005251"/>
              <a:ext cx="997235" cy="485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F202F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251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AEC4E31-7AA0-DD35-9B72-E6AC1E72E6EB}"/>
                </a:ext>
              </a:extLst>
            </p:cNvPr>
            <p:cNvSpPr txBox="1"/>
            <p:nvPr/>
          </p:nvSpPr>
          <p:spPr>
            <a:xfrm>
              <a:off x="3748454" y="1121092"/>
              <a:ext cx="850394" cy="485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FFFF0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324</a:t>
              </a:r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F52FF383-6B9B-7D3A-42AC-756F40E48C03}"/>
              </a:ext>
            </a:extLst>
          </p:cNvPr>
          <p:cNvSpPr txBox="1"/>
          <p:nvPr/>
        </p:nvSpPr>
        <p:spPr>
          <a:xfrm>
            <a:off x="138222" y="7883959"/>
            <a:ext cx="6581553" cy="2006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4000"/>
              </a:lnSpc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.  A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tructure of the CHIKV genome and nsP3.  The positive-sense RNA is capped and polyadenylated and templates translation of the 5′ORF into the four non-structural (ns) proteins which transcribe a negative-sense intermediate.  Transcription of a sub-genomic RNA is then initiated from the sub-genomic promoter (sg-prom) and acts as a template for translation of the 3′ORF encoding the structural proteins.  nsP3 comprises 3 domains: Macro-domain, AUD (alphavirus unique domain), HVD (hypervariable domain).  The structure of the CHIKV dual luciferase sub-genomic replicon (CHIKV SGR-D-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lu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is shown.  R-Luc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Renill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luciferase) is expressed as a fusion within nsP3, FF-Luc (firefly luciferase) is expressed from the sg-prom as a replication reporter. 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1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 Sequence alignment of AUD from multiple alphaviruses indicating key mutated residues.  </a:t>
            </a:r>
            <a:r>
              <a:rPr lang="en-US" altLang="zh-CN" sz="1100" b="1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C</a:t>
            </a:r>
            <a:r>
              <a:rPr lang="en-US" altLang="zh-CN" sz="11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 Ribbon structure of SINV AUD (PDB ID code 4GUA) with the mutants shown in different colors.  Image was constructed using </a:t>
            </a:r>
            <a:r>
              <a:rPr lang="en-US" altLang="zh-CN" sz="1100" dirty="0" err="1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PyMol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18FB6874-F15E-A8CB-CE5B-54E5CA5F0EF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26650" y="1895199"/>
            <a:ext cx="3883103" cy="3282910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A985D7F3-3B5E-7BE8-E3F1-6780EFD84286}"/>
              </a:ext>
            </a:extLst>
          </p:cNvPr>
          <p:cNvSpPr txBox="1"/>
          <p:nvPr/>
        </p:nvSpPr>
        <p:spPr>
          <a:xfrm>
            <a:off x="1049726" y="521128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712895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01DBE70-935C-8DD1-AEB6-26AE3A96EB27}"/>
              </a:ext>
            </a:extLst>
          </p:cNvPr>
          <p:cNvSpPr txBox="1"/>
          <p:nvPr/>
        </p:nvSpPr>
        <p:spPr>
          <a:xfrm>
            <a:off x="340892" y="7330935"/>
            <a:ext cx="6176216" cy="2123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2. Replication of CHIKV AUD mutants in mammalian and mosquito cells.  A</a:t>
            </a:r>
            <a:r>
              <a:rPr lang="en-GB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2C12, </a:t>
            </a:r>
            <a:r>
              <a:rPr lang="en-GB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6/36 and </a:t>
            </a:r>
            <a:r>
              <a:rPr lang="en-GB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U4.4 were transfected with wildtype (WT) or mutant CHIKV-SGR-D-Luc and cells were harvested at indicated time points.  FF-Luc activities of WT and mutants were measured and normalized to their respective 4 h values and thus represent fold-change compared to those 4 h values.  (GAA: nsP4 polymerase inactive mutant).  Significant differences denoted by ** (P&lt;0.01), *** (P&lt;0.001), **** (P&lt;0.0001), compared to WT are only shown for the 12 h time point for clarity.  Data are displayed as the means ±S.E. of three experimental replicates.  </a:t>
            </a:r>
            <a:r>
              <a:rPr lang="en-GB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T-PCR and Sanger sequence chromatographs of CHIKV-SGR-D-Luc W220A, D249A and Y324A in U4.4 and C6/36 cells.  RNA was extracted 72 h post transfection (h.p.t.), followed by RT-PCR and sequence analysis. </a:t>
            </a:r>
            <a:r>
              <a:rPr lang="en-GB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/F</a:t>
            </a:r>
            <a:r>
              <a:rPr lang="en-GB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plication kinetics of WT and AUD mutants in Vero cells. Significant differences denoted by ** (P&lt;0.01), *** (P&lt;0.001), **** (P&lt;0.0001), compared to WT are only shown for the 12 h time point for clarity.</a:t>
            </a:r>
            <a:endParaRPr lang="en-GB" sz="1100" dirty="0"/>
          </a:p>
        </p:txBody>
      </p:sp>
      <p:pic>
        <p:nvPicPr>
          <p:cNvPr id="1026" name="Picture 2" descr="Image preview">
            <a:extLst>
              <a:ext uri="{FF2B5EF4-FFF2-40B4-BE49-F238E27FC236}">
                <a16:creationId xmlns:a16="http://schemas.microsoft.com/office/drawing/2014/main" id="{9DDA4EA4-7C2C-C8F8-25DD-48E436901FD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47762"/>
            <a:ext cx="6858000" cy="58086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380399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aph of different colored bars&#10;&#10;Description automatically generated with medium confidence">
            <a:extLst>
              <a:ext uri="{FF2B5EF4-FFF2-40B4-BE49-F238E27FC236}">
                <a16:creationId xmlns:a16="http://schemas.microsoft.com/office/drawing/2014/main" id="{E55B7873-FAF9-81EF-0F67-F2F74C6D1E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35668"/>
            <a:ext cx="6858000" cy="626306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790526F-AA4B-0DB5-A44F-A2467EB5D816}"/>
              </a:ext>
            </a:extLst>
          </p:cNvPr>
          <p:cNvSpPr txBox="1"/>
          <p:nvPr/>
        </p:nvSpPr>
        <p:spPr>
          <a:xfrm>
            <a:off x="245327" y="7398731"/>
            <a:ext cx="6319229" cy="2292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Enhanced replication at sub-physiological temperature is not dependent on the reporter protein and is not observed for other arboviruses</a:t>
            </a:r>
            <a:r>
              <a:rPr lang="en-GB" sz="11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Schematic of CHIKV SGRs.  CHIKV SGR-nsP3-mCh-FF-Luc was constructed by replacing the R-Luc reporter in CHIKV SGR-D-</a:t>
            </a:r>
            <a:r>
              <a:rPr lang="en-US" sz="1100" dirty="0" err="1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luc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with </a:t>
            </a:r>
            <a:r>
              <a:rPr lang="en-US" sz="1100" dirty="0" err="1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Cherry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.  CHIKV SGR-FF-Luc was constructed by deleting R-Luc and thus expressing WT unfused nsP3.  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C2C12 cells were transfected with the three CHIKV SGRs and incubated at 28°C or 37°C.  Cells were harvested at indicated time points. FF-Luc activities of WT and mutants were measured and normalized to their respective 4 h values and thus represent fold-change compared to those 4 h values (GAA: nsP4 polymerase inactive mutant).  Significant differences denoted by ** (P&lt;0.01) or **** (P&lt;0.0001).  Data are displayed as the means ±S.E. of three experimental replicates.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 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Replication of BUNV mini-genome 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 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nd Zika virus SGR 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at 28°C or 37°C.  Cells were collected at indicated time points and R-Luc or nano-luciferase (nano-</a:t>
            </a:r>
            <a:r>
              <a:rPr lang="en-US" sz="1100" dirty="0" err="1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luc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activities were measured and normalized to their respective 4 h values. </a:t>
            </a:r>
          </a:p>
          <a:p>
            <a:pPr algn="just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19580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DA00B6E-A033-4644-9D74-CAE833E42D25}"/>
              </a:ext>
            </a:extLst>
          </p:cNvPr>
          <p:cNvSpPr txBox="1"/>
          <p:nvPr/>
        </p:nvSpPr>
        <p:spPr>
          <a:xfrm>
            <a:off x="957139" y="1528067"/>
            <a:ext cx="7670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6F0EA2B-494C-492B-AA5B-07A0E38D2DA9}"/>
              </a:ext>
            </a:extLst>
          </p:cNvPr>
          <p:cNvSpPr txBox="1"/>
          <p:nvPr/>
        </p:nvSpPr>
        <p:spPr>
          <a:xfrm>
            <a:off x="481844" y="5416649"/>
            <a:ext cx="598235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. AUD mutant phenotypes in ONNV.  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chematic of ONNV-2SG-ZsGreen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ZsGree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inserted after nsP4 and expressed by a duplicated sub-genomic promoter (sg-prom)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Normalize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ZsGree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xpression of WT and mutant ONNV at 48 h.p.t at 28°C or 37°C. C2C12 cells were transfected with WT and mutant ONNV RNAs and incubated at 28°C or 37°C.  Cells were fixed with 4% formaldehyde at 48 h.p.t.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ZsGree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xpression were scanned and normalized by EVOS microscopy.  *** (P&lt;0.001) **** (P&lt;0.0001), compared to WT at their respective temperature.  Data are displayed as the means ±S.E. of three experimental replicates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102FBC4-5681-47D8-99EF-91E00D754A92}"/>
              </a:ext>
            </a:extLst>
          </p:cNvPr>
          <p:cNvSpPr txBox="1"/>
          <p:nvPr/>
        </p:nvSpPr>
        <p:spPr>
          <a:xfrm>
            <a:off x="1014548" y="895407"/>
            <a:ext cx="1981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 ONNV-2SG-ZsGree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FFCDB861-FECE-49A9-AE18-DACD377A2F59}"/>
              </a:ext>
            </a:extLst>
          </p:cNvPr>
          <p:cNvGrpSpPr/>
          <p:nvPr/>
        </p:nvGrpSpPr>
        <p:grpSpPr>
          <a:xfrm>
            <a:off x="1724234" y="1041041"/>
            <a:ext cx="4067315" cy="425358"/>
            <a:chOff x="5835432" y="2983079"/>
            <a:chExt cx="4067315" cy="425358"/>
          </a:xfrm>
        </p:grpSpPr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731EE2ED-8D08-421A-BA52-1FCBFA7DB12A}"/>
                </a:ext>
              </a:extLst>
            </p:cNvPr>
            <p:cNvCxnSpPr>
              <a:cxnSpLocks/>
            </p:cNvCxnSpPr>
            <p:nvPr/>
          </p:nvCxnSpPr>
          <p:spPr>
            <a:xfrm>
              <a:off x="6129768" y="3300767"/>
              <a:ext cx="3543399" cy="763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199744DE-8E88-402E-A2CB-CB6069F149F7}"/>
                </a:ext>
              </a:extLst>
            </p:cNvPr>
            <p:cNvSpPr txBox="1"/>
            <p:nvPr/>
          </p:nvSpPr>
          <p:spPr>
            <a:xfrm>
              <a:off x="5835432" y="3195991"/>
              <a:ext cx="40102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GB" sz="700" b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lang="en-GB" sz="7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D5DBD972-2FBA-4EE7-B906-97A8A6B4174D}"/>
                </a:ext>
              </a:extLst>
            </p:cNvPr>
            <p:cNvSpPr txBox="1"/>
            <p:nvPr/>
          </p:nvSpPr>
          <p:spPr>
            <a:xfrm>
              <a:off x="9590979" y="3208382"/>
              <a:ext cx="3117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</a:t>
              </a: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48CBE796-83E1-4D38-B879-F13EF5862939}"/>
                </a:ext>
              </a:extLst>
            </p:cNvPr>
            <p:cNvSpPr/>
            <p:nvPr/>
          </p:nvSpPr>
          <p:spPr>
            <a:xfrm>
              <a:off x="6170099" y="3224066"/>
              <a:ext cx="539412" cy="154013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6194D8A3-0E85-49C6-A351-D73125D0821E}"/>
                </a:ext>
              </a:extLst>
            </p:cNvPr>
            <p:cNvSpPr/>
            <p:nvPr/>
          </p:nvSpPr>
          <p:spPr>
            <a:xfrm>
              <a:off x="6709511" y="3224066"/>
              <a:ext cx="539412" cy="154013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35F5E974-E40E-4DA2-9093-63613706860D}"/>
                </a:ext>
              </a:extLst>
            </p:cNvPr>
            <p:cNvSpPr/>
            <p:nvPr/>
          </p:nvSpPr>
          <p:spPr>
            <a:xfrm>
              <a:off x="7248924" y="3224066"/>
              <a:ext cx="539412" cy="154013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1C10E7C6-9B12-4B5B-9A36-F9E9932B634E}"/>
                </a:ext>
              </a:extLst>
            </p:cNvPr>
            <p:cNvSpPr/>
            <p:nvPr/>
          </p:nvSpPr>
          <p:spPr>
            <a:xfrm>
              <a:off x="7788336" y="3224066"/>
              <a:ext cx="539412" cy="154013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AA7ADE9A-1D97-4412-80E9-1C87E2E1600C}"/>
                </a:ext>
              </a:extLst>
            </p:cNvPr>
            <p:cNvSpPr/>
            <p:nvPr/>
          </p:nvSpPr>
          <p:spPr>
            <a:xfrm>
              <a:off x="8803444" y="3223709"/>
              <a:ext cx="823710" cy="154013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0C1FA66E-1AF6-45C9-BFD1-1B891FB9C722}"/>
                </a:ext>
              </a:extLst>
            </p:cNvPr>
            <p:cNvSpPr txBox="1"/>
            <p:nvPr/>
          </p:nvSpPr>
          <p:spPr>
            <a:xfrm>
              <a:off x="8730029" y="3196882"/>
              <a:ext cx="98937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ructural proteins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EB288659-D186-4A86-9052-7B042A0AB01D}"/>
                </a:ext>
              </a:extLst>
            </p:cNvPr>
            <p:cNvSpPr txBox="1"/>
            <p:nvPr/>
          </p:nvSpPr>
          <p:spPr>
            <a:xfrm>
              <a:off x="6233535" y="3191367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P1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428A766-885D-4210-9636-C1722CCDE7E7}"/>
                </a:ext>
              </a:extLst>
            </p:cNvPr>
            <p:cNvSpPr txBox="1"/>
            <p:nvPr/>
          </p:nvSpPr>
          <p:spPr>
            <a:xfrm>
              <a:off x="6781994" y="3191367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P2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E2AF8B7C-4E2A-4099-9F4F-24F0FDA7581E}"/>
                </a:ext>
              </a:extLst>
            </p:cNvPr>
            <p:cNvSpPr txBox="1"/>
            <p:nvPr/>
          </p:nvSpPr>
          <p:spPr>
            <a:xfrm>
              <a:off x="7318655" y="3191367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P3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AD9F6BF9-B326-406F-9342-B451A823C7D1}"/>
                </a:ext>
              </a:extLst>
            </p:cNvPr>
            <p:cNvSpPr txBox="1"/>
            <p:nvPr/>
          </p:nvSpPr>
          <p:spPr>
            <a:xfrm>
              <a:off x="7852041" y="3191367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P4</a:t>
              </a:r>
            </a:p>
          </p:txBody>
        </p:sp>
        <p:sp>
          <p:nvSpPr>
            <p:cNvPr id="64" name="Isosceles Triangle 63">
              <a:extLst>
                <a:ext uri="{FF2B5EF4-FFF2-40B4-BE49-F238E27FC236}">
                  <a16:creationId xmlns:a16="http://schemas.microsoft.com/office/drawing/2014/main" id="{86175FBD-845A-4EAF-85BC-0E96FC5ACFFF}"/>
                </a:ext>
              </a:extLst>
            </p:cNvPr>
            <p:cNvSpPr/>
            <p:nvPr/>
          </p:nvSpPr>
          <p:spPr>
            <a:xfrm rot="16200000" flipV="1">
              <a:off x="8723776" y="3285544"/>
              <a:ext cx="113616" cy="45719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Rectangle 317">
              <a:extLst>
                <a:ext uri="{FF2B5EF4-FFF2-40B4-BE49-F238E27FC236}">
                  <a16:creationId xmlns:a16="http://schemas.microsoft.com/office/drawing/2014/main" id="{22416FB3-3D70-4362-92B9-4921EF671D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43803" y="2988163"/>
              <a:ext cx="1111310" cy="2006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2075" tIns="46038" rIns="92075" bIns="46038">
              <a:spAutoFit/>
            </a:bodyPr>
            <a:lstStyle/>
            <a:p>
              <a:pPr algn="ctr" defTabSz="7620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g-prom</a:t>
              </a: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1006BEEC-835B-4DC6-9C27-255208D7C125}"/>
                </a:ext>
              </a:extLst>
            </p:cNvPr>
            <p:cNvCxnSpPr/>
            <p:nvPr/>
          </p:nvCxnSpPr>
          <p:spPr>
            <a:xfrm flipH="1">
              <a:off x="8757313" y="3166052"/>
              <a:ext cx="883" cy="5409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Isosceles Triangle 66">
              <a:extLst>
                <a:ext uri="{FF2B5EF4-FFF2-40B4-BE49-F238E27FC236}">
                  <a16:creationId xmlns:a16="http://schemas.microsoft.com/office/drawing/2014/main" id="{9CA8921A-0ECC-4F4B-8E36-0102A361D74A}"/>
                </a:ext>
              </a:extLst>
            </p:cNvPr>
            <p:cNvSpPr/>
            <p:nvPr/>
          </p:nvSpPr>
          <p:spPr>
            <a:xfrm rot="16200000" flipV="1">
              <a:off x="8295332" y="3278725"/>
              <a:ext cx="113616" cy="45719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Rectangle 317">
              <a:extLst>
                <a:ext uri="{FF2B5EF4-FFF2-40B4-BE49-F238E27FC236}">
                  <a16:creationId xmlns:a16="http://schemas.microsoft.com/office/drawing/2014/main" id="{2EA2EFFB-BE20-4AA5-AC15-2D6B54E3DA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19345" y="2983079"/>
              <a:ext cx="1111310" cy="2006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2075" tIns="46038" rIns="92075" bIns="46038">
              <a:spAutoFit/>
            </a:bodyPr>
            <a:lstStyle/>
            <a:p>
              <a:pPr algn="ctr" defTabSz="7620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g-prom</a:t>
              </a:r>
            </a:p>
          </p:txBody>
        </p: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8D9D115A-14EE-4DFE-B3A7-7AEB55F77D54}"/>
                </a:ext>
              </a:extLst>
            </p:cNvPr>
            <p:cNvCxnSpPr/>
            <p:nvPr/>
          </p:nvCxnSpPr>
          <p:spPr>
            <a:xfrm flipH="1">
              <a:off x="8339220" y="3166186"/>
              <a:ext cx="883" cy="5409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53E26458-F97A-4FA6-9496-F87E82F549CC}"/>
                </a:ext>
              </a:extLst>
            </p:cNvPr>
            <p:cNvSpPr/>
            <p:nvPr/>
          </p:nvSpPr>
          <p:spPr>
            <a:xfrm>
              <a:off x="8375940" y="3224577"/>
              <a:ext cx="369018" cy="154013"/>
            </a:xfrm>
            <a:prstGeom prst="rect">
              <a:avLst/>
            </a:prstGeom>
            <a:solidFill>
              <a:srgbClr val="00B050"/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DFF399EA-48CA-4BF1-8820-9A2F35BB2826}"/>
                </a:ext>
              </a:extLst>
            </p:cNvPr>
            <p:cNvSpPr txBox="1"/>
            <p:nvPr/>
          </p:nvSpPr>
          <p:spPr>
            <a:xfrm>
              <a:off x="8312762" y="3208382"/>
              <a:ext cx="6028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b="1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sGreen</a:t>
              </a:r>
              <a:endParaRPr lang="en-GB" sz="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C2F03192-F36C-6C47-DC04-3F3BCDB5E02E}"/>
              </a:ext>
            </a:extLst>
          </p:cNvPr>
          <p:cNvGrpSpPr/>
          <p:nvPr/>
        </p:nvGrpSpPr>
        <p:grpSpPr>
          <a:xfrm>
            <a:off x="1173346" y="2076462"/>
            <a:ext cx="4456868" cy="2815540"/>
            <a:chOff x="1173346" y="2076462"/>
            <a:chExt cx="4456868" cy="2815540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02E1C314-B6F0-4FAA-9FF5-F757CD47E77B}"/>
                </a:ext>
              </a:extLst>
            </p:cNvPr>
            <p:cNvGrpSpPr/>
            <p:nvPr/>
          </p:nvGrpSpPr>
          <p:grpSpPr>
            <a:xfrm>
              <a:off x="1659249" y="2284565"/>
              <a:ext cx="3520885" cy="1318703"/>
              <a:chOff x="3106442" y="14765530"/>
              <a:chExt cx="9726918" cy="3643095"/>
            </a:xfrm>
          </p:grpSpPr>
          <p:pic>
            <p:nvPicPr>
              <p:cNvPr id="46" name="Picture 45">
                <a:extLst>
                  <a:ext uri="{FF2B5EF4-FFF2-40B4-BE49-F238E27FC236}">
                    <a16:creationId xmlns:a16="http://schemas.microsoft.com/office/drawing/2014/main" id="{0070D772-C9D1-48E1-BED9-60C2348A237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hq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4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417877" y="14765530"/>
                <a:ext cx="2400000" cy="1800000"/>
              </a:xfrm>
              <a:prstGeom prst="rect">
                <a:avLst/>
              </a:prstGeom>
            </p:spPr>
          </p:pic>
          <p:pic>
            <p:nvPicPr>
              <p:cNvPr id="47" name="Picture 46">
                <a:extLst>
                  <a:ext uri="{FF2B5EF4-FFF2-40B4-BE49-F238E27FC236}">
                    <a16:creationId xmlns:a16="http://schemas.microsoft.com/office/drawing/2014/main" id="{3D6C6B87-2FBB-43B6-9E27-E12BA1D833F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hq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74483" y="14765530"/>
                <a:ext cx="2400000" cy="1800000"/>
              </a:xfrm>
              <a:prstGeom prst="rect">
                <a:avLst/>
              </a:prstGeom>
            </p:spPr>
          </p:pic>
          <p:pic>
            <p:nvPicPr>
              <p:cNvPr id="48" name="Picture 47">
                <a:extLst>
                  <a:ext uri="{FF2B5EF4-FFF2-40B4-BE49-F238E27FC236}">
                    <a16:creationId xmlns:a16="http://schemas.microsoft.com/office/drawing/2014/main" id="{B6E60E55-DB7B-4E37-9A6C-04B8F038D8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hq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4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546428" y="14765530"/>
                <a:ext cx="2400000" cy="1800000"/>
              </a:xfrm>
              <a:prstGeom prst="rect">
                <a:avLst/>
              </a:prstGeom>
            </p:spPr>
          </p:pic>
          <p:pic>
            <p:nvPicPr>
              <p:cNvPr id="49" name="Picture 48">
                <a:extLst>
                  <a:ext uri="{FF2B5EF4-FFF2-40B4-BE49-F238E27FC236}">
                    <a16:creationId xmlns:a16="http://schemas.microsoft.com/office/drawing/2014/main" id="{C4AE261C-21A9-4732-8365-7800D28676B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06442" y="16608625"/>
                <a:ext cx="2400000" cy="1800000"/>
              </a:xfrm>
              <a:prstGeom prst="rect">
                <a:avLst/>
              </a:prstGeom>
            </p:spPr>
          </p:pic>
          <p:pic>
            <p:nvPicPr>
              <p:cNvPr id="50" name="Picture 49">
                <a:extLst>
                  <a:ext uri="{FF2B5EF4-FFF2-40B4-BE49-F238E27FC236}">
                    <a16:creationId xmlns:a16="http://schemas.microsoft.com/office/drawing/2014/main" id="{5536F7C4-9963-46B2-A4DE-750BE6B33C4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hq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06500" y="14765530"/>
                <a:ext cx="2400000" cy="1800000"/>
              </a:xfrm>
              <a:prstGeom prst="rect">
                <a:avLst/>
              </a:prstGeom>
            </p:spPr>
          </p:pic>
          <p:pic>
            <p:nvPicPr>
              <p:cNvPr id="51" name="Picture 50">
                <a:extLst>
                  <a:ext uri="{FF2B5EF4-FFF2-40B4-BE49-F238E27FC236}">
                    <a16:creationId xmlns:a16="http://schemas.microsoft.com/office/drawing/2014/main" id="{2C8AB73F-BD1F-46CA-820B-5B22CBFE6C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546428" y="16598351"/>
                <a:ext cx="2400000" cy="1800000"/>
              </a:xfrm>
              <a:prstGeom prst="rect">
                <a:avLst/>
              </a:prstGeom>
            </p:spPr>
          </p:pic>
          <p:pic>
            <p:nvPicPr>
              <p:cNvPr id="52" name="Picture 51">
                <a:extLst>
                  <a:ext uri="{FF2B5EF4-FFF2-40B4-BE49-F238E27FC236}">
                    <a16:creationId xmlns:a16="http://schemas.microsoft.com/office/drawing/2014/main" id="{CEC92A2F-9D2C-46E0-8521-A0CB34E1A65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84757" y="16598351"/>
                <a:ext cx="2400000" cy="1800000"/>
              </a:xfrm>
              <a:prstGeom prst="rect">
                <a:avLst/>
              </a:prstGeom>
            </p:spPr>
          </p:pic>
          <p:pic>
            <p:nvPicPr>
              <p:cNvPr id="53" name="Picture 52">
                <a:extLst>
                  <a:ext uri="{FF2B5EF4-FFF2-40B4-BE49-F238E27FC236}">
                    <a16:creationId xmlns:a16="http://schemas.microsoft.com/office/drawing/2014/main" id="{C91D1A8D-4087-4C23-B4D2-409464EA287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433360" y="16598351"/>
                <a:ext cx="2400000" cy="1800000"/>
              </a:xfrm>
              <a:prstGeom prst="rect">
                <a:avLst/>
              </a:prstGeom>
            </p:spPr>
          </p:pic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FD47D64-0904-4A2D-BD28-A16545E00EAA}"/>
                </a:ext>
              </a:extLst>
            </p:cNvPr>
            <p:cNvSpPr txBox="1"/>
            <p:nvPr/>
          </p:nvSpPr>
          <p:spPr>
            <a:xfrm>
              <a:off x="1290905" y="2526483"/>
              <a:ext cx="683417" cy="307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7°C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AA3DA1D-0A10-4F03-87ED-F31EA6C643A7}"/>
                </a:ext>
              </a:extLst>
            </p:cNvPr>
            <p:cNvSpPr txBox="1"/>
            <p:nvPr/>
          </p:nvSpPr>
          <p:spPr>
            <a:xfrm>
              <a:off x="1298533" y="3143798"/>
              <a:ext cx="683417" cy="307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8°C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D495464-66C5-40D3-AE88-8125420D0CDC}"/>
                </a:ext>
              </a:extLst>
            </p:cNvPr>
            <p:cNvSpPr txBox="1"/>
            <p:nvPr/>
          </p:nvSpPr>
          <p:spPr>
            <a:xfrm>
              <a:off x="1589026" y="2076462"/>
              <a:ext cx="922392" cy="307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65B4B5A-C5C5-4EA2-85AB-6B83E850159C}"/>
                </a:ext>
              </a:extLst>
            </p:cNvPr>
            <p:cNvSpPr txBox="1"/>
            <p:nvPr/>
          </p:nvSpPr>
          <p:spPr>
            <a:xfrm>
              <a:off x="2560898" y="2081366"/>
              <a:ext cx="922392" cy="307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220A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2F2E314-A4FC-4CD6-9CA5-E0B98C81CF08}"/>
                </a:ext>
              </a:extLst>
            </p:cNvPr>
            <p:cNvSpPr txBox="1"/>
            <p:nvPr/>
          </p:nvSpPr>
          <p:spPr>
            <a:xfrm>
              <a:off x="3421350" y="2081919"/>
              <a:ext cx="922392" cy="307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D249A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8DA6353-4644-4198-9F0E-1415F3DD2850}"/>
                </a:ext>
              </a:extLst>
            </p:cNvPr>
            <p:cNvSpPr txBox="1"/>
            <p:nvPr/>
          </p:nvSpPr>
          <p:spPr>
            <a:xfrm>
              <a:off x="4265140" y="2085348"/>
              <a:ext cx="922392" cy="307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Y324A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3" name="Object 12">
              <a:extLst>
                <a:ext uri="{FF2B5EF4-FFF2-40B4-BE49-F238E27FC236}">
                  <a16:creationId xmlns:a16="http://schemas.microsoft.com/office/drawing/2014/main" id="{E5C6785B-FB58-4B33-B13B-A75D71E03EED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173346" y="3645504"/>
            <a:ext cx="2244796" cy="124649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4" imgW="5012729" imgH="2613278" progId="Prism8.Document">
                    <p:embed/>
                  </p:oleObj>
                </mc:Choice>
                <mc:Fallback>
                  <p:oleObj name="Prism 8" r:id="rId14" imgW="5012729" imgH="2613278" progId="Prism8.Document">
                    <p:embed/>
                    <p:pic>
                      <p:nvPicPr>
                        <p:cNvPr id="13" name="Object 12">
                          <a:extLst>
                            <a:ext uri="{FF2B5EF4-FFF2-40B4-BE49-F238E27FC236}">
                              <a16:creationId xmlns:a16="http://schemas.microsoft.com/office/drawing/2014/main" id="{E5C6785B-FB58-4B33-B13B-A75D71E03EE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1173346" y="3645504"/>
                          <a:ext cx="2244796" cy="124649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5FC46D1D-D3F2-413F-A122-3BE1483F48AD}"/>
                </a:ext>
              </a:extLst>
            </p:cNvPr>
            <p:cNvSpPr txBox="1"/>
            <p:nvPr/>
          </p:nvSpPr>
          <p:spPr>
            <a:xfrm>
              <a:off x="1996209" y="3694670"/>
              <a:ext cx="576743" cy="2851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8°C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74" name="Object 73">
              <a:extLst>
                <a:ext uri="{FF2B5EF4-FFF2-40B4-BE49-F238E27FC236}">
                  <a16:creationId xmlns:a16="http://schemas.microsoft.com/office/drawing/2014/main" id="{19B9E249-3E04-4952-8D99-A113D64683C1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158783" y="3607363"/>
            <a:ext cx="2471431" cy="128463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6" imgW="4971674" imgH="2576542" progId="Prism8.Document">
                    <p:embed/>
                  </p:oleObj>
                </mc:Choice>
                <mc:Fallback>
                  <p:oleObj name="Prism 8" r:id="rId16" imgW="4971674" imgH="2576542" progId="Prism8.Document">
                    <p:embed/>
                    <p:pic>
                      <p:nvPicPr>
                        <p:cNvPr id="74" name="Object 73">
                          <a:extLst>
                            <a:ext uri="{FF2B5EF4-FFF2-40B4-BE49-F238E27FC236}">
                              <a16:creationId xmlns:a16="http://schemas.microsoft.com/office/drawing/2014/main" id="{19B9E249-3E04-4952-8D99-A113D64683C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3158783" y="3607363"/>
                          <a:ext cx="2471431" cy="128463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48A83721-5421-43C3-9B3C-28EC4A9F56D7}"/>
                </a:ext>
              </a:extLst>
            </p:cNvPr>
            <p:cNvSpPr txBox="1"/>
            <p:nvPr/>
          </p:nvSpPr>
          <p:spPr>
            <a:xfrm>
              <a:off x="4421864" y="3716676"/>
              <a:ext cx="576743" cy="2851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7°C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497583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AB8C9A8-4F77-9816-8A10-F30591E5CD6C}"/>
              </a:ext>
            </a:extLst>
          </p:cNvPr>
          <p:cNvSpPr txBox="1"/>
          <p:nvPr/>
        </p:nvSpPr>
        <p:spPr>
          <a:xfrm>
            <a:off x="245327" y="7398731"/>
            <a:ext cx="631922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5. Determination of cytotoxicity 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uxolitinib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uxo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. A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chematic of workflow of experimental protocol for treatment of cells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uxo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and </a:t>
            </a:r>
            <a:r>
              <a:rPr lang="en-US" sz="1200" b="1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 </a:t>
            </a:r>
            <a:r>
              <a:rPr lang="en-US" sz="12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ytotoxicity of </a:t>
            </a:r>
            <a:r>
              <a:rPr lang="en-US" sz="12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Ruxo</a:t>
            </a:r>
            <a:r>
              <a:rPr lang="en-US" sz="12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on C2C12 and Vero cells respectively.</a:t>
            </a:r>
            <a:endParaRPr lang="en-US" sz="1200" dirty="0">
              <a:effectLst/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 algn="just"/>
            <a:endParaRPr lang="en-US" sz="1200" dirty="0">
              <a:effectLst/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DBB1A18-88FE-7E48-17CB-C0152E9830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9235" y="1064777"/>
            <a:ext cx="5110240" cy="1210319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6A950FD-3371-B519-75AE-F0B7FD43541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55559" y="2315819"/>
          <a:ext cx="4127084" cy="19435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6796481" imgH="3200819" progId="Prism10.Document">
                  <p:embed/>
                </p:oleObj>
              </mc:Choice>
              <mc:Fallback>
                <p:oleObj name="Prism 10" r:id="rId3" imgW="6796481" imgH="3200819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6A950FD-3371-B519-75AE-F0B7FD43541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55559" y="2315819"/>
                        <a:ext cx="4127084" cy="19435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" name="Picture 5">
            <a:extLst>
              <a:ext uri="{FF2B5EF4-FFF2-40B4-BE49-F238E27FC236}">
                <a16:creationId xmlns:a16="http://schemas.microsoft.com/office/drawing/2014/main" id="{B3586518-BAC2-7FA9-A165-69B3AC8FE49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14400" y="4334174"/>
            <a:ext cx="2514600" cy="187340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1B6EF40-7211-B81B-F185-7411D514EAD7}"/>
              </a:ext>
            </a:extLst>
          </p:cNvPr>
          <p:cNvSpPr txBox="1"/>
          <p:nvPr/>
        </p:nvSpPr>
        <p:spPr>
          <a:xfrm>
            <a:off x="378922" y="1064777"/>
            <a:ext cx="410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04B8C6E-E23C-8235-B4AA-587C062FA0C2}"/>
              </a:ext>
            </a:extLst>
          </p:cNvPr>
          <p:cNvSpPr txBox="1"/>
          <p:nvPr/>
        </p:nvSpPr>
        <p:spPr>
          <a:xfrm>
            <a:off x="378922" y="2297658"/>
            <a:ext cx="410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35D583E-F13D-A988-813D-EB737FA9D668}"/>
              </a:ext>
            </a:extLst>
          </p:cNvPr>
          <p:cNvSpPr txBox="1"/>
          <p:nvPr/>
        </p:nvSpPr>
        <p:spPr>
          <a:xfrm>
            <a:off x="379003" y="4334174"/>
            <a:ext cx="410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7859680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4F8FE8C-B441-B302-86E6-71A4191FA787}"/>
              </a:ext>
            </a:extLst>
          </p:cNvPr>
          <p:cNvSpPr txBox="1"/>
          <p:nvPr/>
        </p:nvSpPr>
        <p:spPr>
          <a:xfrm>
            <a:off x="665552" y="4537501"/>
            <a:ext cx="50767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6. Change of 6 ISGs in response to CHIKV-D-Luc-WT replication at 28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°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 or 37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°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ulk RNA-seq samples were validated using RT-qPCR with corresponding primers. Fold changes were calculated by comparing WT to GAA and normalized to GAPDH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0BF18289-3F0D-8097-3D0B-EC8BC2FE1C90}"/>
              </a:ext>
            </a:extLst>
          </p:cNvPr>
          <p:cNvGrpSpPr/>
          <p:nvPr/>
        </p:nvGrpSpPr>
        <p:grpSpPr>
          <a:xfrm>
            <a:off x="624674" y="1307134"/>
            <a:ext cx="5117648" cy="2990934"/>
            <a:chOff x="628650" y="450850"/>
            <a:chExt cx="10345448" cy="5956300"/>
          </a:xfrm>
        </p:grpSpPr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1AEE40B1-6110-BFC1-2460-59B1D07A5EE5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7252998" y="450850"/>
            <a:ext cx="3721100" cy="2978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3721642" imgH="2978310" progId="Prism10.Document">
                    <p:embed/>
                  </p:oleObj>
                </mc:Choice>
                <mc:Fallback>
                  <p:oleObj name="Prism 10" r:id="rId2" imgW="3721642" imgH="2978310" progId="Prism10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1AEE40B1-6110-BFC1-2460-59B1D07A5EE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7252998" y="450850"/>
                          <a:ext cx="3721100" cy="2978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0F5281B6-CAB2-E5D3-5E67-6CD39AA41F95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898107" y="450850"/>
            <a:ext cx="3176588" cy="2978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3177117" imgH="2978310" progId="Prism10.Document">
                    <p:embed/>
                  </p:oleObj>
                </mc:Choice>
                <mc:Fallback>
                  <p:oleObj name="Prism 10" r:id="rId4" imgW="3177117" imgH="2978310" progId="Prism10.Document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0F5281B6-CAB2-E5D3-5E67-6CD39AA41F9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898107" y="450850"/>
                          <a:ext cx="3176588" cy="2978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BFD6A1D4-404D-940F-CB79-93C135BBDCC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25726194"/>
                </p:ext>
              </p:extLst>
            </p:nvPr>
          </p:nvGraphicFramePr>
          <p:xfrm>
            <a:off x="628650" y="450850"/>
            <a:ext cx="3090864" cy="2978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3090325" imgH="2978310" progId="Prism10.Document">
                    <p:embed/>
                  </p:oleObj>
                </mc:Choice>
                <mc:Fallback>
                  <p:oleObj name="Prism 10" r:id="rId6" imgW="3090325" imgH="2978310" progId="Prism10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BFD6A1D4-404D-940F-CB79-93C135BBDCC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628650" y="450850"/>
                          <a:ext cx="3090864" cy="2978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ct 8">
              <a:extLst>
                <a:ext uri="{FF2B5EF4-FFF2-40B4-BE49-F238E27FC236}">
                  <a16:creationId xmlns:a16="http://schemas.microsoft.com/office/drawing/2014/main" id="{392DA5C6-9CB9-259E-CBCF-62318E592D55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7407129" y="3429000"/>
            <a:ext cx="3222625" cy="2978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8" imgW="3222855" imgH="2978310" progId="Prism10.Document">
                    <p:embed/>
                  </p:oleObj>
                </mc:Choice>
                <mc:Fallback>
                  <p:oleObj name="Prism 10" r:id="rId8" imgW="3222855" imgH="2978310" progId="Prism10.Document">
                    <p:embed/>
                    <p:pic>
                      <p:nvPicPr>
                        <p:cNvPr id="9" name="Object 8">
                          <a:extLst>
                            <a:ext uri="{FF2B5EF4-FFF2-40B4-BE49-F238E27FC236}">
                              <a16:creationId xmlns:a16="http://schemas.microsoft.com/office/drawing/2014/main" id="{392DA5C6-9CB9-259E-CBCF-62318E592D5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7407129" y="3429000"/>
                          <a:ext cx="3222625" cy="2978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>
              <a:extLst>
                <a:ext uri="{FF2B5EF4-FFF2-40B4-BE49-F238E27FC236}">
                  <a16:creationId xmlns:a16="http://schemas.microsoft.com/office/drawing/2014/main" id="{90F0F82D-FFDB-9B32-09A2-2FD40FD83F3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53040" y="3429000"/>
            <a:ext cx="3108325" cy="2978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0" imgW="3108691" imgH="2978310" progId="Prism10.Document">
                    <p:embed/>
                  </p:oleObj>
                </mc:Choice>
                <mc:Fallback>
                  <p:oleObj name="Prism 10" r:id="rId10" imgW="3108691" imgH="2978310" progId="Prism10.Document">
                    <p:embed/>
                    <p:pic>
                      <p:nvPicPr>
                        <p:cNvPr id="10" name="Object 9">
                          <a:extLst>
                            <a:ext uri="{FF2B5EF4-FFF2-40B4-BE49-F238E27FC236}">
                              <a16:creationId xmlns:a16="http://schemas.microsoft.com/office/drawing/2014/main" id="{90F0F82D-FFDB-9B32-09A2-2FD40FD83F3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653040" y="3429000"/>
                          <a:ext cx="3108325" cy="2978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Object 10">
              <a:extLst>
                <a:ext uri="{FF2B5EF4-FFF2-40B4-BE49-F238E27FC236}">
                  <a16:creationId xmlns:a16="http://schemas.microsoft.com/office/drawing/2014/main" id="{3D9B2B51-62BE-D2DB-AC50-1EE6FE2D4F9E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761365" y="3325524"/>
            <a:ext cx="3230563" cy="2978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2" imgW="3230417" imgH="2978310" progId="Prism10.Document">
                    <p:embed/>
                  </p:oleObj>
                </mc:Choice>
                <mc:Fallback>
                  <p:oleObj name="Prism 10" r:id="rId12" imgW="3230417" imgH="2978310" progId="Prism10.Document">
                    <p:embed/>
                    <p:pic>
                      <p:nvPicPr>
                        <p:cNvPr id="11" name="Object 10">
                          <a:extLst>
                            <a:ext uri="{FF2B5EF4-FFF2-40B4-BE49-F238E27FC236}">
                              <a16:creationId xmlns:a16="http://schemas.microsoft.com/office/drawing/2014/main" id="{3D9B2B51-62BE-D2DB-AC50-1EE6FE2D4F9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3761365" y="3325524"/>
                          <a:ext cx="3230563" cy="2978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17371980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4D6CB6C5-E7A5-4D7F-9EA1-0C261EF764E1}"/>
              </a:ext>
            </a:extLst>
          </p:cNvPr>
          <p:cNvGrpSpPr/>
          <p:nvPr/>
        </p:nvGrpSpPr>
        <p:grpSpPr>
          <a:xfrm>
            <a:off x="346484" y="829435"/>
            <a:ext cx="2961548" cy="2771428"/>
            <a:chOff x="-816147" y="2530281"/>
            <a:chExt cx="8507806" cy="7961638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E0A25A69-3659-483B-8E0E-EDAC9F86F21D}"/>
                </a:ext>
              </a:extLst>
            </p:cNvPr>
            <p:cNvGrpSpPr/>
            <p:nvPr/>
          </p:nvGrpSpPr>
          <p:grpSpPr>
            <a:xfrm>
              <a:off x="-706247" y="2530281"/>
              <a:ext cx="8397906" cy="7961638"/>
              <a:chOff x="-706247" y="2530281"/>
              <a:chExt cx="8397906" cy="7961638"/>
            </a:xfrm>
          </p:grpSpPr>
          <p:pic>
            <p:nvPicPr>
              <p:cNvPr id="67" name="Picture 66">
                <a:extLst>
                  <a:ext uri="{FF2B5EF4-FFF2-40B4-BE49-F238E27FC236}">
                    <a16:creationId xmlns:a16="http://schemas.microsoft.com/office/drawing/2014/main" id="{1C8C9269-46D8-46DE-AFBC-007CED2579D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hq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79479" y="3859285"/>
                <a:ext cx="2160000" cy="2160000"/>
              </a:xfrm>
              <a:prstGeom prst="rect">
                <a:avLst/>
              </a:prstGeom>
            </p:spPr>
          </p:pic>
          <p:pic>
            <p:nvPicPr>
              <p:cNvPr id="68" name="Picture 67">
                <a:extLst>
                  <a:ext uri="{FF2B5EF4-FFF2-40B4-BE49-F238E27FC236}">
                    <a16:creationId xmlns:a16="http://schemas.microsoft.com/office/drawing/2014/main" id="{A233D5EE-F74D-40F5-88A6-DB2F159BEFA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526201" y="3859285"/>
                <a:ext cx="2160000" cy="2160000"/>
              </a:xfrm>
              <a:prstGeom prst="rect">
                <a:avLst/>
              </a:prstGeom>
            </p:spPr>
          </p:pic>
          <p:pic>
            <p:nvPicPr>
              <p:cNvPr id="69" name="Picture 68">
                <a:extLst>
                  <a:ext uri="{FF2B5EF4-FFF2-40B4-BE49-F238E27FC236}">
                    <a16:creationId xmlns:a16="http://schemas.microsoft.com/office/drawing/2014/main" id="{EB0A2C5B-AA33-4887-A7D4-5941C519B9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00887" y="3859285"/>
                <a:ext cx="2160000" cy="2160000"/>
              </a:xfrm>
              <a:prstGeom prst="rect">
                <a:avLst/>
              </a:prstGeom>
            </p:spPr>
          </p:pic>
          <p:pic>
            <p:nvPicPr>
              <p:cNvPr id="73" name="Picture 72">
                <a:extLst>
                  <a:ext uri="{FF2B5EF4-FFF2-40B4-BE49-F238E27FC236}">
                    <a16:creationId xmlns:a16="http://schemas.microsoft.com/office/drawing/2014/main" id="{EB295DBE-16F7-448B-9577-03C29F4EFEF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531659" y="6096441"/>
                <a:ext cx="2160000" cy="2160000"/>
              </a:xfrm>
              <a:prstGeom prst="rect">
                <a:avLst/>
              </a:prstGeom>
            </p:spPr>
          </p:pic>
          <p:pic>
            <p:nvPicPr>
              <p:cNvPr id="74" name="Picture 73">
                <a:extLst>
                  <a:ext uri="{FF2B5EF4-FFF2-40B4-BE49-F238E27FC236}">
                    <a16:creationId xmlns:a16="http://schemas.microsoft.com/office/drawing/2014/main" id="{8B54F65B-36AC-4863-B078-D2B51CD7723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10251" y="6096441"/>
                <a:ext cx="2160000" cy="2160000"/>
              </a:xfrm>
              <a:prstGeom prst="rect">
                <a:avLst/>
              </a:prstGeom>
            </p:spPr>
          </p:pic>
          <p:pic>
            <p:nvPicPr>
              <p:cNvPr id="75" name="Picture 74">
                <a:extLst>
                  <a:ext uri="{FF2B5EF4-FFF2-40B4-BE49-F238E27FC236}">
                    <a16:creationId xmlns:a16="http://schemas.microsoft.com/office/drawing/2014/main" id="{6CCB3AFD-8D99-43E7-A883-54C51EA6B67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79479" y="6096441"/>
                <a:ext cx="2160000" cy="2160000"/>
              </a:xfrm>
              <a:prstGeom prst="rect">
                <a:avLst/>
              </a:prstGeom>
            </p:spPr>
          </p:pic>
          <p:pic>
            <p:nvPicPr>
              <p:cNvPr id="79" name="Picture 78">
                <a:extLst>
                  <a:ext uri="{FF2B5EF4-FFF2-40B4-BE49-F238E27FC236}">
                    <a16:creationId xmlns:a16="http://schemas.microsoft.com/office/drawing/2014/main" id="{55087389-D389-4CAB-B643-042D7BA01E5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531659" y="8331919"/>
                <a:ext cx="2160000" cy="2160000"/>
              </a:xfrm>
              <a:prstGeom prst="rect">
                <a:avLst/>
              </a:prstGeom>
            </p:spPr>
          </p:pic>
          <p:pic>
            <p:nvPicPr>
              <p:cNvPr id="80" name="Picture 79">
                <a:extLst>
                  <a:ext uri="{FF2B5EF4-FFF2-40B4-BE49-F238E27FC236}">
                    <a16:creationId xmlns:a16="http://schemas.microsoft.com/office/drawing/2014/main" id="{3B6C87D3-90F0-4723-AC75-DB21C650151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00887" y="8331919"/>
                <a:ext cx="2160000" cy="2160000"/>
              </a:xfrm>
              <a:prstGeom prst="rect">
                <a:avLst/>
              </a:prstGeom>
            </p:spPr>
          </p:pic>
          <p:pic>
            <p:nvPicPr>
              <p:cNvPr id="81" name="Picture 80">
                <a:extLst>
                  <a:ext uri="{FF2B5EF4-FFF2-40B4-BE49-F238E27FC236}">
                    <a16:creationId xmlns:a16="http://schemas.microsoft.com/office/drawing/2014/main" id="{E1694291-F20D-4986-B463-BD212B0FF59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70115" y="8320031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6307B313-13D0-46B1-B5A9-07FFEC766D6B}"/>
                  </a:ext>
                </a:extLst>
              </p:cNvPr>
              <p:cNvSpPr txBox="1"/>
              <p:nvPr/>
            </p:nvSpPr>
            <p:spPr>
              <a:xfrm>
                <a:off x="3719280" y="2530281"/>
                <a:ext cx="1741603" cy="7957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8°C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1A63F333-F814-487B-8D45-C5E021A3344E}"/>
                  </a:ext>
                </a:extLst>
              </p:cNvPr>
              <p:cNvSpPr txBox="1"/>
              <p:nvPr/>
            </p:nvSpPr>
            <p:spPr>
              <a:xfrm>
                <a:off x="1279431" y="3303745"/>
                <a:ext cx="1752979" cy="7073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3BP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C76917F3-3580-44F2-A9D6-B08DF7EFCD9D}"/>
                  </a:ext>
                </a:extLst>
              </p:cNvPr>
              <p:cNvSpPr txBox="1"/>
              <p:nvPr/>
            </p:nvSpPr>
            <p:spPr>
              <a:xfrm>
                <a:off x="3604086" y="3303745"/>
                <a:ext cx="1553598" cy="7073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378E7583-6F1B-456D-9EAF-1EECE31B7245}"/>
                  </a:ext>
                </a:extLst>
              </p:cNvPr>
              <p:cNvSpPr txBox="1"/>
              <p:nvPr/>
            </p:nvSpPr>
            <p:spPr>
              <a:xfrm>
                <a:off x="5695722" y="3311524"/>
                <a:ext cx="1973115" cy="7073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rge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9B506B5E-A04F-40EA-A3FB-123A4A815D21}"/>
                  </a:ext>
                </a:extLst>
              </p:cNvPr>
              <p:cNvSpPr txBox="1"/>
              <p:nvPr/>
            </p:nvSpPr>
            <p:spPr>
              <a:xfrm>
                <a:off x="-329924" y="4677675"/>
                <a:ext cx="1553598" cy="7073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9AB8CE00-58BC-401C-8B75-1D7583B06FD5}"/>
                  </a:ext>
                </a:extLst>
              </p:cNvPr>
              <p:cNvSpPr txBox="1"/>
              <p:nvPr/>
            </p:nvSpPr>
            <p:spPr>
              <a:xfrm>
                <a:off x="-706247" y="6911146"/>
                <a:ext cx="1940205" cy="7073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aAsO</a:t>
                </a:r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</p:grp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EE97843E-6E19-4C57-ACBC-51707366936A}"/>
                </a:ext>
              </a:extLst>
            </p:cNvPr>
            <p:cNvSpPr txBox="1"/>
            <p:nvPr/>
          </p:nvSpPr>
          <p:spPr>
            <a:xfrm>
              <a:off x="-816147" y="8901305"/>
              <a:ext cx="2160000" cy="11494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aAsO</a:t>
              </a:r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CHX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A26A955F-54CD-484F-BF09-6A88096BACA2}"/>
              </a:ext>
            </a:extLst>
          </p:cNvPr>
          <p:cNvGrpSpPr/>
          <p:nvPr/>
        </p:nvGrpSpPr>
        <p:grpSpPr>
          <a:xfrm>
            <a:off x="3345241" y="820822"/>
            <a:ext cx="2950187" cy="2783482"/>
            <a:chOff x="7317281" y="2495653"/>
            <a:chExt cx="8475169" cy="7996266"/>
          </a:xfrm>
        </p:grpSpPr>
        <p:pic>
          <p:nvPicPr>
            <p:cNvPr id="70" name="Picture 69">
              <a:extLst>
                <a:ext uri="{FF2B5EF4-FFF2-40B4-BE49-F238E27FC236}">
                  <a16:creationId xmlns:a16="http://schemas.microsoft.com/office/drawing/2014/main" id="{C0DF9A5C-BEDE-487E-9D36-E579C7BCA57F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628941" y="3859285"/>
              <a:ext cx="2160000" cy="2160000"/>
            </a:xfrm>
            <a:prstGeom prst="rect">
              <a:avLst/>
            </a:prstGeom>
          </p:spPr>
        </p:pic>
        <p:pic>
          <p:nvPicPr>
            <p:cNvPr id="71" name="Picture 70">
              <a:extLst>
                <a:ext uri="{FF2B5EF4-FFF2-40B4-BE49-F238E27FC236}">
                  <a16:creationId xmlns:a16="http://schemas.microsoft.com/office/drawing/2014/main" id="{7AF10CB2-CAC7-45D0-A69B-63A38005C0B7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06809" y="3859285"/>
              <a:ext cx="2160000" cy="2160000"/>
            </a:xfrm>
            <a:prstGeom prst="rect">
              <a:avLst/>
            </a:prstGeom>
          </p:spPr>
        </p:pic>
        <p:pic>
          <p:nvPicPr>
            <p:cNvPr id="72" name="Picture 71">
              <a:extLst>
                <a:ext uri="{FF2B5EF4-FFF2-40B4-BE49-F238E27FC236}">
                  <a16:creationId xmlns:a16="http://schemas.microsoft.com/office/drawing/2014/main" id="{988872D1-C5CC-4B01-A1AF-C872168D7022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hq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86244" y="3859285"/>
              <a:ext cx="2160000" cy="2160000"/>
            </a:xfrm>
            <a:prstGeom prst="rect">
              <a:avLst/>
            </a:prstGeom>
          </p:spPr>
        </p:pic>
        <p:pic>
          <p:nvPicPr>
            <p:cNvPr id="76" name="Picture 75">
              <a:extLst>
                <a:ext uri="{FF2B5EF4-FFF2-40B4-BE49-F238E27FC236}">
                  <a16:creationId xmlns:a16="http://schemas.microsoft.com/office/drawing/2014/main" id="{08B5533B-F45E-4850-8D67-2236755567FD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08655" y="6086860"/>
              <a:ext cx="2160000" cy="2160000"/>
            </a:xfrm>
            <a:prstGeom prst="rect">
              <a:avLst/>
            </a:prstGeom>
          </p:spPr>
        </p:pic>
        <p:pic>
          <p:nvPicPr>
            <p:cNvPr id="77" name="Picture 76">
              <a:extLst>
                <a:ext uri="{FF2B5EF4-FFF2-40B4-BE49-F238E27FC236}">
                  <a16:creationId xmlns:a16="http://schemas.microsoft.com/office/drawing/2014/main" id="{DF713509-8F5F-4ECF-A0A6-B7759583049F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632450" y="6089464"/>
              <a:ext cx="2160000" cy="2160000"/>
            </a:xfrm>
            <a:prstGeom prst="rect">
              <a:avLst/>
            </a:prstGeom>
          </p:spPr>
        </p:pic>
        <p:pic>
          <p:nvPicPr>
            <p:cNvPr id="78" name="Picture 77">
              <a:extLst>
                <a:ext uri="{FF2B5EF4-FFF2-40B4-BE49-F238E27FC236}">
                  <a16:creationId xmlns:a16="http://schemas.microsoft.com/office/drawing/2014/main" id="{F63B236A-31F4-4574-870F-10F8254F0453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89148" y="6087563"/>
              <a:ext cx="2160000" cy="2160000"/>
            </a:xfrm>
            <a:prstGeom prst="rect">
              <a:avLst/>
            </a:prstGeom>
          </p:spPr>
        </p:pic>
        <p:pic>
          <p:nvPicPr>
            <p:cNvPr id="82" name="Picture 81">
              <a:extLst>
                <a:ext uri="{FF2B5EF4-FFF2-40B4-BE49-F238E27FC236}">
                  <a16:creationId xmlns:a16="http://schemas.microsoft.com/office/drawing/2014/main" id="{A14470B3-9DB2-4D62-BC50-D6CFCF465E65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89657" y="8324719"/>
              <a:ext cx="2160000" cy="2160000"/>
            </a:xfrm>
            <a:prstGeom prst="rect">
              <a:avLst/>
            </a:prstGeom>
          </p:spPr>
        </p:pic>
        <p:pic>
          <p:nvPicPr>
            <p:cNvPr id="83" name="Picture 82">
              <a:extLst>
                <a:ext uri="{FF2B5EF4-FFF2-40B4-BE49-F238E27FC236}">
                  <a16:creationId xmlns:a16="http://schemas.microsoft.com/office/drawing/2014/main" id="{0A0F7EA4-EA4A-41BC-AB92-5D1CE7FA0197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630032" y="8317631"/>
              <a:ext cx="2160000" cy="2160000"/>
            </a:xfrm>
            <a:prstGeom prst="rect">
              <a:avLst/>
            </a:prstGeom>
          </p:spPr>
        </p:pic>
        <p:pic>
          <p:nvPicPr>
            <p:cNvPr id="84" name="Picture 83">
              <a:extLst>
                <a:ext uri="{FF2B5EF4-FFF2-40B4-BE49-F238E27FC236}">
                  <a16:creationId xmlns:a16="http://schemas.microsoft.com/office/drawing/2014/main" id="{6236949C-8C58-4884-8E51-44A3F3985743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08655" y="8331919"/>
              <a:ext cx="2160000" cy="2160000"/>
            </a:xfrm>
            <a:prstGeom prst="rect">
              <a:avLst/>
            </a:prstGeom>
          </p:spPr>
        </p:pic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A766529C-5A5E-405C-89A2-62E55CE343BF}"/>
                </a:ext>
              </a:extLst>
            </p:cNvPr>
            <p:cNvSpPr txBox="1"/>
            <p:nvPr/>
          </p:nvSpPr>
          <p:spPr>
            <a:xfrm>
              <a:off x="11909965" y="2495653"/>
              <a:ext cx="1656842" cy="7957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7°C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F122C0C6-6EBF-4F74-B117-043635763E69}"/>
                </a:ext>
              </a:extLst>
            </p:cNvPr>
            <p:cNvSpPr txBox="1"/>
            <p:nvPr/>
          </p:nvSpPr>
          <p:spPr>
            <a:xfrm>
              <a:off x="9505115" y="3328284"/>
              <a:ext cx="1805674" cy="707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3BP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A8F3CBB7-6915-47C0-ADD2-008FC832ACB6}"/>
                </a:ext>
              </a:extLst>
            </p:cNvPr>
            <p:cNvSpPr txBox="1"/>
            <p:nvPr/>
          </p:nvSpPr>
          <p:spPr>
            <a:xfrm>
              <a:off x="11848827" y="3328284"/>
              <a:ext cx="1553598" cy="707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D71ACD9E-BEDD-4A87-89F0-DB5F6B91FE1B}"/>
                </a:ext>
              </a:extLst>
            </p:cNvPr>
            <p:cNvSpPr txBox="1"/>
            <p:nvPr/>
          </p:nvSpPr>
          <p:spPr>
            <a:xfrm>
              <a:off x="13940461" y="3314799"/>
              <a:ext cx="1656842" cy="707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971D2D63-FFC7-4E66-9146-7A8E6BA4118C}"/>
                </a:ext>
              </a:extLst>
            </p:cNvPr>
            <p:cNvSpPr txBox="1"/>
            <p:nvPr/>
          </p:nvSpPr>
          <p:spPr>
            <a:xfrm>
              <a:off x="7812814" y="4741175"/>
              <a:ext cx="1553598" cy="707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6D3D7CB4-EC95-435D-9B9F-CCB1848307D5}"/>
                </a:ext>
              </a:extLst>
            </p:cNvPr>
            <p:cNvSpPr txBox="1"/>
            <p:nvPr/>
          </p:nvSpPr>
          <p:spPr>
            <a:xfrm>
              <a:off x="7317281" y="6894449"/>
              <a:ext cx="2069517" cy="707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aAsO</a:t>
              </a:r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  <p:sp>
        <p:nvSpPr>
          <p:cNvPr id="66" name="TextBox 65">
            <a:extLst>
              <a:ext uri="{FF2B5EF4-FFF2-40B4-BE49-F238E27FC236}">
                <a16:creationId xmlns:a16="http://schemas.microsoft.com/office/drawing/2014/main" id="{03E96DFF-D506-4D87-A13E-9994759C511C}"/>
              </a:ext>
            </a:extLst>
          </p:cNvPr>
          <p:cNvSpPr txBox="1"/>
          <p:nvPr/>
        </p:nvSpPr>
        <p:spPr>
          <a:xfrm>
            <a:off x="3363292" y="3047174"/>
            <a:ext cx="715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aAsO</a:t>
            </a:r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CHX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766B0A1A-55E0-44B1-8B99-70BB0A0C4619}"/>
              </a:ext>
            </a:extLst>
          </p:cNvPr>
          <p:cNvSpPr txBox="1"/>
          <p:nvPr/>
        </p:nvSpPr>
        <p:spPr>
          <a:xfrm>
            <a:off x="479798" y="791784"/>
            <a:ext cx="576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441DC113-3CC6-4077-A2A6-3AAA1BB55448}"/>
              </a:ext>
            </a:extLst>
          </p:cNvPr>
          <p:cNvSpPr txBox="1"/>
          <p:nvPr/>
        </p:nvSpPr>
        <p:spPr>
          <a:xfrm>
            <a:off x="470749" y="3809505"/>
            <a:ext cx="576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4" name="Object 43">
            <a:extLst>
              <a:ext uri="{FF2B5EF4-FFF2-40B4-BE49-F238E27FC236}">
                <a16:creationId xmlns:a16="http://schemas.microsoft.com/office/drawing/2014/main" id="{0349C36F-059D-4478-8D90-942CCB2248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3255717"/>
              </p:ext>
            </p:extLst>
          </p:nvPr>
        </p:nvGraphicFramePr>
        <p:xfrm>
          <a:off x="641350" y="3803650"/>
          <a:ext cx="2976563" cy="2289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3" imgW="4065932" imgH="3121095" progId="Prism9.Document">
                  <p:embed/>
                </p:oleObj>
              </mc:Choice>
              <mc:Fallback>
                <p:oleObj name="Prism 9" r:id="rId23" imgW="4065932" imgH="3121095" progId="Prism9.Document">
                  <p:embed/>
                  <p:pic>
                    <p:nvPicPr>
                      <p:cNvPr id="44" name="Object 43">
                        <a:extLst>
                          <a:ext uri="{FF2B5EF4-FFF2-40B4-BE49-F238E27FC236}">
                            <a16:creationId xmlns:a16="http://schemas.microsoft.com/office/drawing/2014/main" id="{0349C36F-059D-4478-8D90-942CCB2248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641350" y="3803650"/>
                        <a:ext cx="2976563" cy="2289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ct 44">
            <a:extLst>
              <a:ext uri="{FF2B5EF4-FFF2-40B4-BE49-F238E27FC236}">
                <a16:creationId xmlns:a16="http://schemas.microsoft.com/office/drawing/2014/main" id="{2EA892FC-A724-4807-BC61-13F3A457BE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2927343"/>
              </p:ext>
            </p:extLst>
          </p:nvPr>
        </p:nvGraphicFramePr>
        <p:xfrm>
          <a:off x="3517735" y="3832028"/>
          <a:ext cx="3114675" cy="2214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5" imgW="4389334" imgH="3121095" progId="Prism9.Document">
                  <p:embed/>
                </p:oleObj>
              </mc:Choice>
              <mc:Fallback>
                <p:oleObj name="Prism 9" r:id="rId25" imgW="4389334" imgH="3121095" progId="Prism9.Document">
                  <p:embed/>
                  <p:pic>
                    <p:nvPicPr>
                      <p:cNvPr id="45" name="Object 44">
                        <a:extLst>
                          <a:ext uri="{FF2B5EF4-FFF2-40B4-BE49-F238E27FC236}">
                            <a16:creationId xmlns:a16="http://schemas.microsoft.com/office/drawing/2014/main" id="{2EA892FC-A724-4807-BC61-13F3A457BE8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3517735" y="3832028"/>
                        <a:ext cx="3114675" cy="2214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3" name="TextBox 42">
            <a:extLst>
              <a:ext uri="{FF2B5EF4-FFF2-40B4-BE49-F238E27FC236}">
                <a16:creationId xmlns:a16="http://schemas.microsoft.com/office/drawing/2014/main" id="{3B44B1A5-54CE-4993-839A-DF20573D586C}"/>
              </a:ext>
            </a:extLst>
          </p:cNvPr>
          <p:cNvSpPr txBox="1"/>
          <p:nvPr/>
        </p:nvSpPr>
        <p:spPr>
          <a:xfrm>
            <a:off x="3530078" y="3813917"/>
            <a:ext cx="576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0B071F6-B825-475D-8210-27E152141DF6}"/>
              </a:ext>
            </a:extLst>
          </p:cNvPr>
          <p:cNvSpPr txBox="1"/>
          <p:nvPr/>
        </p:nvSpPr>
        <p:spPr>
          <a:xfrm>
            <a:off x="515737" y="6329938"/>
            <a:ext cx="587865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7. Stress granule (SG) formation in uninfected cells at 28°C or 37°C.  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D cells were incubated at 28°C or 37°C.  Cells were either mock treated or treated with 0.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odium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rsenit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NaAsO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for 1 h.  Cells were then either immediately fixed with 4% paraformaldehyde or treated with 100 µg/ml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ycloheximid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CHX) for 45 min prior to fixation.  Cells were then stained with G3BP1 antibody (red).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Quantification of G3BP1 protein expression from mock, NaAsO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NaAsO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 CHX treated cells at different temperatures. Values were determined for 10 cells and calculated by Fiji ImageJ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 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he number of SGs were determined for 10 cells.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7243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EBE1F2E9378164293747440797002E1" ma:contentTypeVersion="14" ma:contentTypeDescription="Create a new document." ma:contentTypeScope="" ma:versionID="72750924408a46d0bc416c320e64fba3">
  <xsd:schema xmlns:xsd="http://www.w3.org/2001/XMLSchema" xmlns:xs="http://www.w3.org/2001/XMLSchema" xmlns:p="http://schemas.microsoft.com/office/2006/metadata/properties" xmlns:ns3="02b47265-d29e-45fa-98e4-0426aab083c1" xmlns:ns4="00504d6a-c067-4a3b-bd01-73b095e68220" targetNamespace="http://schemas.microsoft.com/office/2006/metadata/properties" ma:root="true" ma:fieldsID="256f8b7a8e8c2b73c9a1cc80abf4e793" ns3:_="" ns4:_="">
    <xsd:import namespace="02b47265-d29e-45fa-98e4-0426aab083c1"/>
    <xsd:import namespace="00504d6a-c067-4a3b-bd01-73b095e6822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2b47265-d29e-45fa-98e4-0426aab083c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description="" ma:internalName="MediaServiceAutoTags" ma:readOnly="true">
      <xsd:simpleType>
        <xsd:restriction base="dms:Text"/>
      </xsd:simpleType>
    </xsd:element>
    <xsd:element name="MediaServiceLocation" ma:index="12" nillable="true" ma:displayName="MediaServiceLocation" ma:description="" ma:internalName="MediaServiceLocatio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0504d6a-c067-4a3b-bd01-73b095e68220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58A60B6A-42E8-497B-B05E-0548BABEF2A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2b47265-d29e-45fa-98e4-0426aab083c1"/>
    <ds:schemaRef ds:uri="00504d6a-c067-4a3b-bd01-73b095e6822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24A45E68-B9C4-452A-BFAA-BF89F297C8D3}">
  <ds:schemaRefs>
    <ds:schemaRef ds:uri="http://schemas.microsoft.com/office/2006/metadata/properties"/>
    <ds:schemaRef ds:uri="http://purl.org/dc/elements/1.1/"/>
    <ds:schemaRef ds:uri="http://purl.org/dc/terms/"/>
    <ds:schemaRef ds:uri="00504d6a-c067-4a3b-bd01-73b095e68220"/>
    <ds:schemaRef ds:uri="http://schemas.microsoft.com/office/infopath/2007/PartnerControls"/>
    <ds:schemaRef ds:uri="http://schemas.microsoft.com/office/2006/documentManagement/types"/>
    <ds:schemaRef ds:uri="http://www.w3.org/XML/1998/namespace"/>
    <ds:schemaRef ds:uri="02b47265-d29e-45fa-98e4-0426aab083c1"/>
    <ds:schemaRef ds:uri="http://schemas.openxmlformats.org/package/2006/metadata/core-properties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F275D5A1-3322-40F4-BFA9-D9A375C6B833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729</TotalTime>
  <Words>1017</Words>
  <Application>Microsoft Office PowerPoint</Application>
  <PresentationFormat>A4 Paper (210x297 mm)</PresentationFormat>
  <Paragraphs>61</Paragraphs>
  <Slides>7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rism 8</vt:lpstr>
      <vt:lpstr>Prism 10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nchao Guo</dc:creator>
  <cp:lastModifiedBy>Mark Harris</cp:lastModifiedBy>
  <cp:revision>141</cp:revision>
  <cp:lastPrinted>2025-01-22T10:36:30Z</cp:lastPrinted>
  <dcterms:created xsi:type="dcterms:W3CDTF">2021-06-26T22:49:47Z</dcterms:created>
  <dcterms:modified xsi:type="dcterms:W3CDTF">2025-03-12T14:35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EBE1F2E9378164293747440797002E1</vt:lpwstr>
  </property>
</Properties>
</file>